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20" y="74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30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069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9139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5725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209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0770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2439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7536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8529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6661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0321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1F55-6E25-4ABE-9611-D26A72A2E369}" type="datetimeFigureOut">
              <a:rPr lang="de-DE" smtClean="0"/>
              <a:t>23.04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4A4A-EB1B-4203-BD32-96284088B57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446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5.tiff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emf"/><Relationship Id="rId4" Type="http://schemas.openxmlformats.org/officeDocument/2006/relationships/image" Target="../media/image6.tiff"/><Relationship Id="rId9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ieren 13"/>
          <p:cNvGrpSpPr>
            <a:grpSpLocks noChangeAspect="1"/>
          </p:cNvGrpSpPr>
          <p:nvPr/>
        </p:nvGrpSpPr>
        <p:grpSpPr>
          <a:xfrm>
            <a:off x="3650936" y="4139942"/>
            <a:ext cx="2884142" cy="1282859"/>
            <a:chOff x="1419225" y="2564291"/>
            <a:chExt cx="3090470" cy="1374633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40" t="45756" r="52661" b="48946"/>
            <a:stretch/>
          </p:blipFill>
          <p:spPr>
            <a:xfrm>
              <a:off x="1419225" y="3254054"/>
              <a:ext cx="2447925" cy="3245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40" t="44295" r="52661" b="50591"/>
            <a:stretch/>
          </p:blipFill>
          <p:spPr>
            <a:xfrm>
              <a:off x="1419225" y="3625895"/>
              <a:ext cx="2447925" cy="3130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Textfeld 5"/>
            <p:cNvSpPr txBox="1"/>
            <p:nvPr/>
          </p:nvSpPr>
          <p:spPr>
            <a:xfrm rot="16200000">
              <a:off x="1562100" y="300698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M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 rot="16200000">
              <a:off x="1790700" y="2843473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NEG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#1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 rot="16200000">
              <a:off x="2152607" y="2843473"/>
              <a:ext cx="6783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NEG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#2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2483609" y="2807515"/>
              <a:ext cx="733793" cy="247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EDI3 #4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 rot="16200000">
              <a:off x="2835578" y="2807515"/>
              <a:ext cx="733793" cy="2473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EDI3 #1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 rot="16200000">
              <a:off x="3261195" y="2840267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EDI3 #5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3889303" y="3312545"/>
              <a:ext cx="493104" cy="215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EDI3</a:t>
              </a: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3889303" y="3666993"/>
              <a:ext cx="6203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DE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8576369"/>
              </p:ext>
            </p:extLst>
          </p:nvPr>
        </p:nvGraphicFramePr>
        <p:xfrm>
          <a:off x="646113" y="1237171"/>
          <a:ext cx="2330450" cy="2916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0" name="Prism 10" r:id="rId5" imgW="2648078" imgH="3313057" progId="Prism10.Document">
                  <p:embed/>
                </p:oleObj>
              </mc:Choice>
              <mc:Fallback>
                <p:oleObj name="Prism 10" r:id="rId5" imgW="2648078" imgH="331305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46113" y="1237171"/>
                        <a:ext cx="2330450" cy="2916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1154050"/>
              </p:ext>
            </p:extLst>
          </p:nvPr>
        </p:nvGraphicFramePr>
        <p:xfrm>
          <a:off x="3526896" y="1061466"/>
          <a:ext cx="2338388" cy="3092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1" name="Prism 10" r:id="rId7" imgW="2657441" imgH="3514383" progId="Prism10.Document">
                  <p:embed/>
                </p:oleObj>
              </mc:Choice>
              <mc:Fallback>
                <p:oleObj name="Prism 10" r:id="rId7" imgW="2657441" imgH="351438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26896" y="1061466"/>
                        <a:ext cx="2338388" cy="3092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8755582"/>
              </p:ext>
            </p:extLst>
          </p:nvPr>
        </p:nvGraphicFramePr>
        <p:xfrm>
          <a:off x="6415617" y="1200658"/>
          <a:ext cx="2201862" cy="2916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2" name="Prism 9" r:id="rId9" imgW="2652760" imgH="3514383" progId="Prism9.Document">
                  <p:embed/>
                </p:oleObj>
              </mc:Choice>
              <mc:Fallback>
                <p:oleObj name="Prism 9" r:id="rId9" imgW="2652760" imgH="351438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415617" y="1200658"/>
                        <a:ext cx="2201862" cy="2916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2533148"/>
              </p:ext>
            </p:extLst>
          </p:nvPr>
        </p:nvGraphicFramePr>
        <p:xfrm>
          <a:off x="9167813" y="1213358"/>
          <a:ext cx="2551112" cy="2916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3" name="Prism 10" r:id="rId11" imgW="2811219" imgH="3210773" progId="Prism10.Document">
                  <p:embed/>
                </p:oleObj>
              </mc:Choice>
              <mc:Fallback>
                <p:oleObj name="Prism 10" r:id="rId11" imgW="2811219" imgH="321077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167813" y="1213358"/>
                        <a:ext cx="2551112" cy="2916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5"/>
          <p:cNvSpPr txBox="1"/>
          <p:nvPr/>
        </p:nvSpPr>
        <p:spPr>
          <a:xfrm>
            <a:off x="584856" y="5982935"/>
            <a:ext cx="1113406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v-SE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v-S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ilencing EDI3 in SUM190PT cells using siRNA reduces resistance to anoikis and viability in adherent cells. (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) EDI3 mRNA and (B) protein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expression after silencing EDI3 in SUM190PT cells compared with cells transfected with 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wo different scrambled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siRNA (</a:t>
            </a:r>
            <a:r>
              <a:rPr lang="sv-S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iNEG #1 and #2). </a:t>
            </a:r>
            <a:r>
              <a:rPr lang="sv-SE" sz="1050" dirty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in RFU relative to negative control measured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(C) non-adherent cells 48 h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lating on a poly-HEMA matrix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D) adherent cells 96 h after plating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ata represent mean ± SD from three independent experiments (*, p &lt; 0.05; ***, p &lt; 0.001). FM, full media control; RFU, relative fluorescence units.</a:t>
            </a:r>
            <a:endParaRPr lang="sv-S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646113" y="116655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526896" y="116655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6299056" y="11665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9066743" y="11665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254839" y="1325027"/>
            <a:ext cx="1450848" cy="2399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4117784" y="1114116"/>
            <a:ext cx="1679399" cy="2399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/>
          <p:cNvSpPr/>
          <p:nvPr/>
        </p:nvSpPr>
        <p:spPr>
          <a:xfrm>
            <a:off x="7036027" y="1221590"/>
            <a:ext cx="1450848" cy="2399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/>
          <p:cNvSpPr/>
          <p:nvPr/>
        </p:nvSpPr>
        <p:spPr>
          <a:xfrm>
            <a:off x="9997616" y="1276278"/>
            <a:ext cx="1450848" cy="2399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Textfeld 2"/>
          <p:cNvSpPr txBox="1"/>
          <p:nvPr/>
        </p:nvSpPr>
        <p:spPr>
          <a:xfrm>
            <a:off x="1589490" y="1053182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4428386" y="1060876"/>
            <a:ext cx="97654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I3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7356975" y="1060876"/>
            <a:ext cx="670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oikis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0226580" y="1060876"/>
            <a:ext cx="96853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5725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Breitbild</PresentationFormat>
  <Paragraphs>17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rism 9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ika Glotzbach</dc:creator>
  <cp:lastModifiedBy>Annika Glotzbach</cp:lastModifiedBy>
  <cp:revision>22</cp:revision>
  <dcterms:created xsi:type="dcterms:W3CDTF">2024-04-17T11:49:01Z</dcterms:created>
  <dcterms:modified xsi:type="dcterms:W3CDTF">2024-04-23T13:36:29Z</dcterms:modified>
</cp:coreProperties>
</file>